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Diagnosi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Complete Responders</c:v>
                </c:pt>
                <c:pt idx="1">
                  <c:v>Partial Responders</c:v>
                </c:pt>
                <c:pt idx="2">
                  <c:v>Non-Responders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0.77</c:v>
                </c:pt>
                <c:pt idx="1">
                  <c:v>0.8</c:v>
                </c:pt>
                <c:pt idx="2">
                  <c:v>0.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5E-4BAB-BBFB-23F65591E527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End of Induction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Sheet1!$A$2:$A$4</c:f>
              <c:strCache>
                <c:ptCount val="3"/>
                <c:pt idx="0">
                  <c:v>Complete Responders</c:v>
                </c:pt>
                <c:pt idx="1">
                  <c:v>Partial Responders</c:v>
                </c:pt>
                <c:pt idx="2">
                  <c:v>Non-Responders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-0.3</c:v>
                </c:pt>
                <c:pt idx="1">
                  <c:v>0.87</c:v>
                </c:pt>
                <c:pt idx="2">
                  <c:v>1.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35E-4BAB-BBFB-23F65591E5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4049904"/>
        <c:axId val="544044656"/>
      </c:barChart>
      <c:catAx>
        <c:axId val="54404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044656"/>
        <c:crosses val="autoZero"/>
        <c:auto val="1"/>
        <c:lblAlgn val="ctr"/>
        <c:lblOffset val="100"/>
        <c:noMultiLvlLbl val="0"/>
      </c:catAx>
      <c:valAx>
        <c:axId val="5440446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Absolute RAIL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44049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3175"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3/01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1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74436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3200" b="1" dirty="0">
                <a:solidFill>
                  <a:schemeClr val="bg1"/>
                </a:solidFill>
              </a:rPr>
              <a:t>Urine biomarker score captures response to induction therapy with lupus nephritis </a:t>
            </a:r>
            <a:endParaRPr lang="en-US" sz="32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RAIL Scores correspond to those lupus nephritis patients who respond to induction therapy 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ody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pRAIL score detects response during induction therapy, with improvement of 1 or more indicating complete response to induction therapy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81499" y="28928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1040033" y="2690059"/>
            <a:ext cx="1438761" cy="1424726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128 pediatric &amp; young adult SLE patients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 flipV="1">
            <a:off x="2538170" y="3423903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3301452" y="2690059"/>
            <a:ext cx="1376344" cy="1424725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RAIL scores differ by LN status</a:t>
            </a:r>
          </a:p>
        </p:txBody>
      </p:sp>
      <p:cxnSp>
        <p:nvCxnSpPr>
          <p:cNvPr id="19" name="Straight Arrow Connector 18"/>
          <p:cNvCxnSpPr/>
          <p:nvPr/>
        </p:nvCxnSpPr>
        <p:spPr>
          <a:xfrm flipV="1">
            <a:off x="4732483" y="3396658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/>
          <p:cNvSpPr/>
          <p:nvPr/>
        </p:nvSpPr>
        <p:spPr>
          <a:xfrm>
            <a:off x="5448316" y="2690059"/>
            <a:ext cx="1387781" cy="1424725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25 pediatric LN patients at start of induction therapy</a:t>
            </a:r>
          </a:p>
        </p:txBody>
      </p:sp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2645347070"/>
              </p:ext>
            </p:extLst>
          </p:nvPr>
        </p:nvGraphicFramePr>
        <p:xfrm>
          <a:off x="7679856" y="1828800"/>
          <a:ext cx="4439663" cy="35269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4" name="Straight Arrow Connector 13"/>
          <p:cNvCxnSpPr>
            <a:stCxn id="22" idx="3"/>
          </p:cNvCxnSpPr>
          <p:nvPr/>
        </p:nvCxnSpPr>
        <p:spPr>
          <a:xfrm>
            <a:off x="6836097" y="3402422"/>
            <a:ext cx="837113" cy="15403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94</TotalTime>
  <Words>80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4</cp:revision>
  <dcterms:created xsi:type="dcterms:W3CDTF">2019-06-13T12:30:18Z</dcterms:created>
  <dcterms:modified xsi:type="dcterms:W3CDTF">2023-01-14T00:31:41Z</dcterms:modified>
</cp:coreProperties>
</file>